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58" r:id="rId3"/>
    <p:sldId id="259" r:id="rId4"/>
    <p:sldId id="260" r:id="rId5"/>
    <p:sldId id="261" r:id="rId6"/>
    <p:sldId id="266" r:id="rId7"/>
    <p:sldId id="263" r:id="rId8"/>
    <p:sldId id="264" r:id="rId9"/>
    <p:sldId id="265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598591-DD6D-497F-83AD-FA8ADD481834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5DFC2C-0766-44E0-8010-184570AC7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108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89895C-63EA-42C2-9D25-07B9B585F5C1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063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89895C-63EA-42C2-9D25-07B9B585F5C1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2678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89895C-63EA-42C2-9D25-07B9B585F5C1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284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DD652-272E-4A6F-8461-1F2F3040002D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57522-4DD2-498A-A676-A7B0FA44EB0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76200"/>
            <a:ext cx="7772400" cy="5334000"/>
          </a:xfrm>
          <a:prstGeom prst="rect">
            <a:avLst/>
          </a:prstGeom>
          <a:noFill/>
          <a:ln w="9525">
            <a:solidFill>
              <a:srgbClr val="00B0F0"/>
            </a:solidFill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152400" y="5715000"/>
            <a:ext cx="8686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Figure S1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 Distribution of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DArTSeq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SNPs on 21 bread wheat chromosomes. The number of SNPs identified on each chromosome is described at the top of the chromosomes.   A, B and D sub-genome totally harbored 10,317, 10,979 and 9,756 SNPs,  respectively.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2399" y="76200"/>
            <a:ext cx="8849719" cy="6553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Rectangle 6"/>
          <p:cNvSpPr/>
          <p:nvPr/>
        </p:nvSpPr>
        <p:spPr>
          <a:xfrm>
            <a:off x="2133600" y="4876800"/>
            <a:ext cx="67056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. Quantile-quantile plots indicating how well the GWAS model accounted for population structure and kinship for each of the disease traits. Only significant marker-trait-association studies were reported. In each plot, the observ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–log (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 values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rom the fitted GWAS models (y-axis) are compared with their expected value (x-axis) under the null hypothesis of no association with the trait. Each blue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do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presents 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ingle nucleotide polymorphism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, the red line is the model for no assosaation. SDSH, Septoria disease severity at heding; SDSMM, Septoria disease severity at mid-maturity; SDSM, Septoria disease severity at maturity; SPC, Septoria progress coefficient. Holeta, Bekoji and Kulumsa represent the study locations,while 2015 and 2016  are the phenotyping yesrs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/>
          <p:cNvPicPr>
            <a:picLocks noChangeAspect="1" noChangeArrowheads="1"/>
          </p:cNvPicPr>
          <p:nvPr/>
        </p:nvPicPr>
        <p:blipFill>
          <a:blip r:embed="rId2" cstate="print"/>
          <a:srcRect t="80417"/>
          <a:stretch>
            <a:fillRect/>
          </a:stretch>
        </p:blipFill>
        <p:spPr bwMode="auto">
          <a:xfrm>
            <a:off x="228600" y="304800"/>
            <a:ext cx="8610600" cy="362726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5" name="Rectangle 4"/>
          <p:cNvSpPr/>
          <p:nvPr/>
        </p:nvSpPr>
        <p:spPr>
          <a:xfrm>
            <a:off x="762000" y="4140875"/>
            <a:ext cx="75438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r>
              <a:rPr lang="it-IT" dirty="0" smtClean="0">
                <a:latin typeface="Times New Roman" pitchFamily="18" charset="0"/>
                <a:cs typeface="Times New Roman" pitchFamily="18" charset="0"/>
              </a:rPr>
              <a:t>. Manhattan plot for GWA scan for Septoria progress cofficient measured over two years (pooled data). Each dot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represents a SNP. </a:t>
            </a:r>
            <a:r>
              <a:rPr lang="it-IT" dirty="0" smtClean="0">
                <a:latin typeface="Times New Roman" pitchFamily="18" charset="0"/>
                <a:cs typeface="Times New Roman" pitchFamily="18" charset="0"/>
              </a:rPr>
              <a:t> On the X-axis is the genomic position of the SNPs on the corresponding chromosomes indicated in diffrent colours. On the Y-axis is the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log10 of the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value signifying the significance of the association test. </a:t>
            </a:r>
            <a:r>
              <a:rPr lang="it-IT" dirty="0" smtClean="0">
                <a:latin typeface="Times New Roman" pitchFamily="18" charset="0"/>
                <a:cs typeface="Times New Roman" pitchFamily="18" charset="0"/>
              </a:rPr>
              <a:t>The horizontal red line is the Bonferroni correction significance threshold used in the assotion study of SPC (Septoria progress cofficent) combined across three locations over two years.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/>
          <p:cNvPicPr>
            <a:picLocks noChangeAspect="1" noChangeArrowheads="1"/>
          </p:cNvPicPr>
          <p:nvPr/>
        </p:nvPicPr>
        <p:blipFill>
          <a:blip r:embed="rId2" cstate="print"/>
          <a:srcRect b="75914"/>
          <a:stretch>
            <a:fillRect/>
          </a:stretch>
        </p:blipFill>
        <p:spPr bwMode="auto">
          <a:xfrm>
            <a:off x="76199" y="76200"/>
            <a:ext cx="5257801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10"/>
          <p:cNvPicPr>
            <a:picLocks noChangeAspect="1" noChangeArrowheads="1"/>
          </p:cNvPicPr>
          <p:nvPr/>
        </p:nvPicPr>
        <p:blipFill>
          <a:blip r:embed="rId2" cstate="print"/>
          <a:srcRect t="49319" b="25448"/>
          <a:stretch>
            <a:fillRect/>
          </a:stretch>
        </p:blipFill>
        <p:spPr bwMode="auto">
          <a:xfrm>
            <a:off x="0" y="1676400"/>
            <a:ext cx="5257800" cy="1771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3" cstate="print"/>
          <a:srcRect b="59819"/>
          <a:stretch>
            <a:fillRect/>
          </a:stretch>
        </p:blipFill>
        <p:spPr bwMode="auto">
          <a:xfrm>
            <a:off x="228600" y="3352800"/>
            <a:ext cx="5105400" cy="335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7"/>
          <p:cNvSpPr/>
          <p:nvPr/>
        </p:nvSpPr>
        <p:spPr>
          <a:xfrm>
            <a:off x="5334000" y="4060210"/>
            <a:ext cx="3657600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Figure S4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. Manhattan plots for Septoria disease severity traits measured in 2015. Only GWA scans resulting in significant associations are reported. Each do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presents a SNP.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 On the X-axis is the genomic position of the SNPs on the corresponding chromosomes indicated in diffrent colours..Y-axis is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log10 of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value depicting the significance of the association test.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The horizontal red line is the Bonferroni correction significance threshold used in the assotion studies of SDSH (Septoria disease severity at heding), SDSMM (Septoria disease severity at mid-maturity), and SPC (Septoria progress cofficient ) at Holeta and Kulumsa locations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457200" y="5689937"/>
            <a:ext cx="8382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Figure S5.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Manhattan plots for Septoria disease severity data measured in 2016. Only GWA scans resulting in significant associations are presented. Each dot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presents a SNP.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 On the X-axis is the genomic position of the SNPs on the corresponding chromosomes indicated in diffrent colours.  On the Y-axis is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log10 of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value depicting the significance of the association test.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The horizontal red line is the Bonferroni significance threshold used in the assotion studies of SDSH, Septoria disease severity at heding; SDSM, Septoria disease severity at maturity;  and SPC, Septoria progress cofficient at Bekoji and Kulumsa  locations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3" cstate="print"/>
          <a:srcRect t="24086" b="50681"/>
          <a:stretch>
            <a:fillRect/>
          </a:stretch>
        </p:blipFill>
        <p:spPr bwMode="auto">
          <a:xfrm>
            <a:off x="0" y="0"/>
            <a:ext cx="5029200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10"/>
          <p:cNvPicPr>
            <a:picLocks noChangeAspect="1" noChangeArrowheads="1"/>
          </p:cNvPicPr>
          <p:nvPr/>
        </p:nvPicPr>
        <p:blipFill>
          <a:blip r:embed="rId3" cstate="print"/>
          <a:srcRect t="74552"/>
          <a:stretch>
            <a:fillRect/>
          </a:stretch>
        </p:blipFill>
        <p:spPr bwMode="auto">
          <a:xfrm>
            <a:off x="0" y="1828800"/>
            <a:ext cx="5029200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4" cstate="print"/>
          <a:srcRect t="60272" b="19466"/>
          <a:stretch>
            <a:fillRect/>
          </a:stretch>
        </p:blipFill>
        <p:spPr bwMode="auto">
          <a:xfrm>
            <a:off x="5029200" y="228600"/>
            <a:ext cx="4114800" cy="220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4" cstate="print"/>
          <a:srcRect t="40181" b="39728"/>
          <a:stretch>
            <a:fillRect/>
          </a:stretch>
        </p:blipFill>
        <p:spPr bwMode="auto">
          <a:xfrm>
            <a:off x="76200" y="3626642"/>
            <a:ext cx="4953000" cy="20121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81000" y="5068669"/>
            <a:ext cx="8229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7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6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ome-wide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LD decade plot over physical distance based on 7,776 SNP marker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llow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represents the model fits to L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cay.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The blue dash-line represents the arbitrary threshold for no LD used (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it-IT" sz="1200" i="1" baseline="30000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=0.2).</a:t>
            </a:r>
            <a:r>
              <a:rPr lang="it-IT" sz="1200" b="1" i="1" baseline="30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ght green li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the intersection between critica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map distance to determine QTL confidence intervals.</a:t>
            </a:r>
          </a:p>
        </p:txBody>
      </p:sp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457200"/>
            <a:ext cx="8001000" cy="461146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311233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52400" y="0"/>
            <a:ext cx="1625599" cy="243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981200" y="76200"/>
            <a:ext cx="1752600" cy="24730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810000" y="62166"/>
            <a:ext cx="1676400" cy="26810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638800" y="76200"/>
            <a:ext cx="1676400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7315200" y="76200"/>
            <a:ext cx="1752600" cy="2514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76200" y="2590800"/>
            <a:ext cx="1752600" cy="243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981200" y="2590800"/>
            <a:ext cx="1828799" cy="259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910013" y="2819400"/>
            <a:ext cx="1652587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7458075" y="2667000"/>
            <a:ext cx="1609725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5638800" y="2743200"/>
            <a:ext cx="1800225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8" name="Picture 12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76200" y="5029200"/>
            <a:ext cx="1828800" cy="1752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9" name="Picture 13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057400" y="5181600"/>
            <a:ext cx="1771651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Rectangle 17"/>
          <p:cNvSpPr/>
          <p:nvPr/>
        </p:nvSpPr>
        <p:spPr>
          <a:xfrm>
            <a:off x="3962400" y="5165973"/>
            <a:ext cx="5029200" cy="16850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150" b="1" dirty="0" smtClean="0">
                <a:latin typeface="Times New Roman" pitchFamily="18" charset="0"/>
                <a:cs typeface="Times New Roman" pitchFamily="18" charset="0"/>
              </a:rPr>
              <a:t>Figure S7</a:t>
            </a:r>
            <a:r>
              <a:rPr lang="it-IT" sz="1150" dirty="0" smtClean="0">
                <a:latin typeface="Times New Roman" pitchFamily="18" charset="0"/>
                <a:cs typeface="Times New Roman" pitchFamily="18" charset="0"/>
              </a:rPr>
              <a:t>. Quantile-quantile plots for the GWAS model used for each of the agronomic traits. Only significant marker-trait-association are reported. In each plot, the observed </a:t>
            </a:r>
            <a:r>
              <a:rPr lang="en-US" sz="1150" dirty="0" smtClean="0">
                <a:latin typeface="Times New Roman" pitchFamily="18" charset="0"/>
                <a:cs typeface="Times New Roman" pitchFamily="18" charset="0"/>
              </a:rPr>
              <a:t>–log (</a:t>
            </a:r>
            <a:r>
              <a:rPr lang="en-US" sz="1150" i="1" dirty="0" smtClean="0">
                <a:latin typeface="Times New Roman" pitchFamily="18" charset="0"/>
                <a:cs typeface="Times New Roman" pitchFamily="18" charset="0"/>
              </a:rPr>
              <a:t>P values) </a:t>
            </a:r>
            <a:r>
              <a:rPr lang="en-US" sz="1150" dirty="0" smtClean="0">
                <a:latin typeface="Times New Roman" pitchFamily="18" charset="0"/>
                <a:cs typeface="Times New Roman" pitchFamily="18" charset="0"/>
              </a:rPr>
              <a:t>from the GWAS models (y-axis) are compared with their expected value (x-axis). Each blue </a:t>
            </a:r>
            <a:r>
              <a:rPr lang="it-IT" sz="1150" dirty="0" smtClean="0">
                <a:latin typeface="Times New Roman" pitchFamily="18" charset="0"/>
                <a:cs typeface="Times New Roman" pitchFamily="18" charset="0"/>
              </a:rPr>
              <a:t>dot </a:t>
            </a:r>
            <a:r>
              <a:rPr lang="en-US" sz="1150" dirty="0" smtClean="0">
                <a:latin typeface="Times New Roman" pitchFamily="18" charset="0"/>
                <a:cs typeface="Times New Roman" pitchFamily="18" charset="0"/>
              </a:rPr>
              <a:t>represents a</a:t>
            </a:r>
            <a:r>
              <a:rPr lang="en-US" sz="115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50" dirty="0" smtClean="0">
                <a:latin typeface="Times New Roman" pitchFamily="18" charset="0"/>
                <a:cs typeface="Times New Roman" pitchFamily="18" charset="0"/>
              </a:rPr>
              <a:t>SNP, and </a:t>
            </a:r>
            <a:r>
              <a:rPr lang="it-IT" sz="1150" dirty="0" smtClean="0">
                <a:latin typeface="Times New Roman" pitchFamily="18" charset="0"/>
                <a:cs typeface="Times New Roman" pitchFamily="18" charset="0"/>
              </a:rPr>
              <a:t>the red line is the model for no assosaation. FarmCPU, the used model,  HD, days to heading; DF, days to flowering;D M, days to maturity; GFD; grain filling duration, PH, plant height; TKW, thousand kernels weight. Holeta, Bekoji and Kulumsa are study locations while 2015 and 2016 decribe the phenotyping yesrs. Combined indicates pooled phenotype data.   </a:t>
            </a:r>
            <a:endParaRPr lang="en-US" sz="115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54" name="Picture 10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9422" y="152400"/>
            <a:ext cx="8765978" cy="6477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Rectangle 17"/>
          <p:cNvSpPr/>
          <p:nvPr/>
        </p:nvSpPr>
        <p:spPr>
          <a:xfrm>
            <a:off x="4495800" y="4572000"/>
            <a:ext cx="4572000" cy="160043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it-IT" sz="1400" b="1" dirty="0" smtClean="0">
                <a:latin typeface="Times New Roman" pitchFamily="18" charset="0"/>
                <a:cs typeface="Times New Roman" pitchFamily="18" charset="0"/>
              </a:rPr>
              <a:t>Figure S8 </a:t>
            </a:r>
            <a:r>
              <a:rPr lang="it-IT" sz="1400" dirty="0" smtClean="0">
                <a:latin typeface="Times New Roman" pitchFamily="18" charset="0"/>
                <a:cs typeface="Times New Roman" pitchFamily="18" charset="0"/>
              </a:rPr>
              <a:t>. Manhattan plots for the GWA scan on agronomic traits measured in 2015. On the x-axis is the genomic position of the SNPs on the corresponding chromosomes indicated in diffrent colours, and  on the y-axis is th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-log10 of the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value depicting the significance of the association test.</a:t>
            </a:r>
            <a:r>
              <a:rPr lang="it-IT" sz="1400" dirty="0" smtClean="0">
                <a:latin typeface="Times New Roman" pitchFamily="18" charset="0"/>
                <a:cs typeface="Times New Roman" pitchFamily="18" charset="0"/>
              </a:rPr>
              <a:t> The horizontal red line represents the Bonferroni correction significance threshold at 0.15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 cstate="print"/>
          <a:srcRect b="26526"/>
          <a:stretch>
            <a:fillRect/>
          </a:stretch>
        </p:blipFill>
        <p:spPr bwMode="auto">
          <a:xfrm>
            <a:off x="76200" y="63364"/>
            <a:ext cx="4343400" cy="44324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19601" y="76200"/>
            <a:ext cx="4724400" cy="5924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76200" y="5015805"/>
            <a:ext cx="4495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Figure S9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. Manhattan plots for the GWA scan on agronomic and yield related traits measured in 2016 and pooled data. On the x-axis is the genomic position of the SNPs on the corresponding chromosomes indicated in diffrent colours. On the y-axis is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ignificance of the association test in -log10 of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-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value .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 The horizontal red line is the Bonferroni significance threshold used in this study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35</Words>
  <Application>Microsoft Office PowerPoint</Application>
  <PresentationFormat>On-screen Show (4:3)</PresentationFormat>
  <Paragraphs>12</Paragraphs>
  <Slides>9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trl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USER</cp:lastModifiedBy>
  <cp:revision>4</cp:revision>
  <dcterms:created xsi:type="dcterms:W3CDTF">2021-05-29T20:51:35Z</dcterms:created>
  <dcterms:modified xsi:type="dcterms:W3CDTF">2021-08-13T15:05:49Z</dcterms:modified>
</cp:coreProperties>
</file>